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pptx" ContentType="application/vnd.openxmlformats-officedocument.presentationml.presentation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tr-TR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9583315-FDB3-4571-B2A7-D0DE4531C007}" type="slidenum">
              <a:rPr b="0" lang="tr-T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1F3E503-5338-4A1D-AECC-BB77F3FDF9F5}" type="slidenum">
              <a:rPr b="0" lang="tr-TR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tr-TR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50DE4-1AE3-445F-B8DB-92254277E6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2F8CEA-681A-45AD-A0D3-C8C2E96CCC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91D517-32DC-42BD-B387-727A7E8D89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714AE-1DCA-4536-9743-11CA62D2293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395DE-61B1-439E-A7D8-E9DB6D82F8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90DF3-B5E4-4220-A8C9-00B3C996285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E800C0-B567-4520-87FC-DCD799EEE4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1786C-353F-4790-A386-839ABD3EDB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B0B77-5299-47EB-93DC-9A8334D2BA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508B2-0DEA-4F72-8F62-4C42DF8280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BFC3F1-9F10-4D59-AF6C-12A087BEEE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96A89-F27F-43A5-A7AD-1A954BF8F7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tr-T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083B753-37B4-4587-95D8-88B0F78EFB2E}" type="slidenum">
              <a:rPr b="0" lang="tr-T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ppt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539640" y="333360"/>
          <a:ext cx="7920000" cy="6264360"/>
        </p:xfrm>
        <a:graphic>
          <a:graphicData uri="http://schemas.openxmlformats.org/presentationml/2006/ole">
            <p:oleObj progId="PowerPoint.Show.12"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39640" y="333360"/>
                    <a:ext cx="7920000" cy="6264360"/>
                  </a:xfrm>
                  <a:prstGeom prst="rect">
                    <a:avLst/>
                  </a:prstGeom>
                  <a:ln w="38160">
                    <a:solidFill>
                      <a:srgbClr val="333399"/>
                    </a:solidFill>
                    <a:miter/>
                  </a:ln>
                </p:spPr>
              </p:pic>
            </p:oleObj>
          </a:graphicData>
        </a:graphic>
      </p:graphicFrame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539640" y="378000"/>
            <a:ext cx="7848720" cy="529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1800" spc="-1" strike="noStrike">
                <a:solidFill>
                  <a:srgbClr val="000000"/>
                </a:solidFill>
                <a:latin typeface="Comic Sans MS"/>
              </a:rPr>
              <a:t>Figure S 2. Helicobacter pylori prevalence in Turkey by regio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"/>
          <p:cNvSpPr/>
          <p:nvPr/>
        </p:nvSpPr>
        <p:spPr>
          <a:xfrm>
            <a:off x="2743200" y="3124080"/>
            <a:ext cx="40384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6"/>
          <p:cNvSpPr/>
          <p:nvPr/>
        </p:nvSpPr>
        <p:spPr>
          <a:xfrm>
            <a:off x="3564000" y="3213000"/>
            <a:ext cx="151452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"/>
          <p:cNvSpPr/>
          <p:nvPr/>
        </p:nvSpPr>
        <p:spPr>
          <a:xfrm>
            <a:off x="3059280" y="2997360"/>
            <a:ext cx="2376360" cy="1008720"/>
          </a:xfrm>
          <a:prstGeom prst="rect">
            <a:avLst/>
          </a:prstGeom>
          <a:solidFill>
            <a:srgbClr val="3333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ffffff"/>
                </a:solidFill>
                <a:latin typeface="Arial"/>
              </a:rPr>
              <a:t>Central of Turkey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ffffff"/>
                </a:solidFill>
                <a:latin typeface="Arial"/>
              </a:rPr>
              <a:t>85.1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r-TR" sz="2000" spc="-1" strike="noStrike">
                <a:solidFill>
                  <a:srgbClr val="ffffff"/>
                </a:solidFill>
                <a:latin typeface="Arial"/>
              </a:rPr>
              <a:t>(95% CI 82.8,87.3)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8"/>
          <p:cNvSpPr/>
          <p:nvPr/>
        </p:nvSpPr>
        <p:spPr>
          <a:xfrm>
            <a:off x="3348000" y="4365720"/>
            <a:ext cx="115272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"/>
          <p:cNvSpPr/>
          <p:nvPr/>
        </p:nvSpPr>
        <p:spPr>
          <a:xfrm>
            <a:off x="2916360" y="4149720"/>
            <a:ext cx="2374920" cy="123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South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78.7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r-TR" sz="1600" spc="-1" strike="noStrike">
                <a:solidFill>
                  <a:srgbClr val="000000"/>
                </a:solidFill>
                <a:latin typeface="Arial"/>
              </a:rPr>
              <a:t>(95% CI 73.3,84.4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10"/>
          <p:cNvSpPr/>
          <p:nvPr/>
        </p:nvSpPr>
        <p:spPr>
          <a:xfrm>
            <a:off x="900000" y="2997360"/>
            <a:ext cx="1943280" cy="123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West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80.3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r-TR" sz="1600" spc="-1" strike="noStrike">
                <a:solidFill>
                  <a:srgbClr val="000000"/>
                </a:solidFill>
                <a:latin typeface="Arial"/>
              </a:rPr>
              <a:t>(95% CI 77.4,83.5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11"/>
          <p:cNvSpPr/>
          <p:nvPr/>
        </p:nvSpPr>
        <p:spPr>
          <a:xfrm>
            <a:off x="5508720" y="2924280"/>
            <a:ext cx="1942920" cy="123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East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87.8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r-TR" sz="1600" spc="-1" strike="noStrike">
                <a:solidFill>
                  <a:srgbClr val="000000"/>
                </a:solidFill>
                <a:latin typeface="Arial"/>
              </a:rPr>
              <a:t>(95% CI 85.8,90.1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12"/>
          <p:cNvSpPr/>
          <p:nvPr/>
        </p:nvSpPr>
        <p:spPr>
          <a:xfrm>
            <a:off x="3059280" y="1628640"/>
            <a:ext cx="2374560" cy="1233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North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2000" spc="-1" strike="noStrike">
                <a:solidFill>
                  <a:srgbClr val="000000"/>
                </a:solidFill>
                <a:latin typeface="Arial"/>
              </a:rPr>
              <a:t>82.4%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tr-TR" sz="1600" spc="-1" strike="noStrike">
                <a:solidFill>
                  <a:srgbClr val="000000"/>
                </a:solidFill>
                <a:latin typeface="Arial"/>
              </a:rPr>
              <a:t>(95% CI 78.9,86.4</a:t>
            </a:r>
            <a:r>
              <a:rPr b="0" lang="tr-TR" sz="1600" spc="-1" strike="noStrike">
                <a:solidFill>
                  <a:srgbClr val="000000"/>
                </a:solidFill>
                <a:latin typeface="Comic Sans MS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13"/>
          <p:cNvSpPr/>
          <p:nvPr/>
        </p:nvSpPr>
        <p:spPr>
          <a:xfrm>
            <a:off x="2050920" y="6093000"/>
            <a:ext cx="4464360" cy="337320"/>
          </a:xfrm>
          <a:prstGeom prst="rect">
            <a:avLst/>
          </a:prstGeom>
          <a:solidFill>
            <a:srgbClr val="333399"/>
          </a:solidFill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tr-TR" sz="1600" spc="-1" strike="noStrike">
                <a:solidFill>
                  <a:srgbClr val="ffff00"/>
                </a:solidFill>
                <a:latin typeface="Comic Sans MS"/>
              </a:rPr>
              <a:t>Turkey</a:t>
            </a:r>
            <a:r>
              <a:rPr b="0" lang="tr-TR" sz="1600" spc="-1" strike="noStrike">
                <a:solidFill>
                  <a:srgbClr val="ffff00"/>
                </a:solidFill>
                <a:latin typeface="Comic Sans MS"/>
              </a:rPr>
              <a:t>: </a:t>
            </a:r>
            <a:r>
              <a:rPr b="1" lang="tr-TR" sz="1600" spc="-1" strike="noStrike">
                <a:solidFill>
                  <a:srgbClr val="ffff00"/>
                </a:solidFill>
                <a:latin typeface="Comic Sans MS"/>
              </a:rPr>
              <a:t>82.5% </a:t>
            </a:r>
            <a:r>
              <a:rPr b="0" lang="tr-TR" sz="1600" spc="-1" strike="noStrike">
                <a:solidFill>
                  <a:srgbClr val="ffff00"/>
                </a:solidFill>
                <a:latin typeface="Arial"/>
              </a:rPr>
              <a:t>(95% CI </a:t>
            </a:r>
            <a:r>
              <a:rPr b="1" lang="tr-TR" sz="1600" spc="-1" strike="noStrike">
                <a:solidFill>
                  <a:srgbClr val="ffff00"/>
                </a:solidFill>
                <a:latin typeface="Arial"/>
              </a:rPr>
              <a:t>81.0, 84.2)</a:t>
            </a:r>
            <a:r>
              <a:rPr b="0" lang="tr-TR" sz="1600" spc="-1" strike="noStrike">
                <a:solidFill>
                  <a:srgbClr val="ffff00"/>
                </a:solidFill>
                <a:latin typeface="Comic Sans MS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1-05T20:59:23Z</dcterms:created>
  <dc:creator>PC1109283</dc:creator>
  <dc:description/>
  <dc:language>en-US</dc:language>
  <cp:lastModifiedBy>nilüfer</cp:lastModifiedBy>
  <dcterms:modified xsi:type="dcterms:W3CDTF">2013-11-24T18:43:38Z</dcterms:modified>
  <cp:revision>36</cp:revision>
  <dc:subject/>
  <dc:title>Slide 1</dc:title>
</cp:coreProperties>
</file>